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7" r:id="rId2"/>
  </p:sldIdLst>
  <p:sldSz cx="12192000" cy="6858000"/>
  <p:notesSz cx="9923463" cy="67945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cientific Editor" initials="SE" lastIdx="9" clrIdx="0">
    <p:extLst>
      <p:ext uri="{19B8F6BF-5375-455C-9EA6-DF929625EA0E}">
        <p15:presenceInfo xmlns:p15="http://schemas.microsoft.com/office/powerpoint/2012/main" userId="Scientific Editor" providerId="None"/>
      </p:ext>
    </p:extLst>
  </p:cmAuthor>
  <p:cmAuthor id="2" name="takesue" initials="t" lastIdx="5" clrIdx="1">
    <p:extLst>
      <p:ext uri="{19B8F6BF-5375-455C-9EA6-DF929625EA0E}">
        <p15:presenceInfo xmlns:p15="http://schemas.microsoft.com/office/powerpoint/2012/main" userId="takesu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426" autoAdjust="0"/>
    <p:restoredTop sz="95529" autoAdjust="0"/>
  </p:normalViewPr>
  <p:slideViewPr>
    <p:cSldViewPr snapToGrid="0">
      <p:cViewPr varScale="1">
        <p:scale>
          <a:sx n="110" d="100"/>
          <a:sy n="110" d="100"/>
        </p:scale>
        <p:origin x="104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1127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r">
              <a:defRPr sz="1200"/>
            </a:lvl1pPr>
          </a:lstStyle>
          <a:p>
            <a:fld id="{EE51A95F-65DE-4144-A4F9-634112008E7B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924175" y="849313"/>
            <a:ext cx="4075113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3" tIns="45702" rIns="91403" bIns="4570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1871" y="3270310"/>
            <a:ext cx="7939722" cy="2675275"/>
          </a:xfrm>
          <a:prstGeom prst="rect">
            <a:avLst/>
          </a:prstGeom>
        </p:spPr>
        <p:txBody>
          <a:bodyPr vert="horz" lIns="91403" tIns="45702" rIns="91403" bIns="4570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1127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r">
              <a:defRPr sz="1200"/>
            </a:lvl1pPr>
          </a:lstStyle>
          <a:p>
            <a:fld id="{E3776AED-F714-4E36-B15F-2F7F9B335F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79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oad-spectrum antibiotics which is predominantly used for community acquired infections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776AED-F714-4E36-B15F-2F7F9B335F9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49515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805445-C5E7-8F3D-996C-AD90650695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033B15-A4F8-6D06-28C0-1A2D4026D0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C87F14-493E-DD58-B161-EC24192C3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D18E99-8411-65B0-2E48-739DF1C67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33CEF5-EDC4-F417-EB78-DBB057DCE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679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698543-C304-D1F8-0D6B-FCEE75674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3D4BEDC-5958-8A32-4BEA-4DA0480924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837EBE-E13E-9DBC-A607-854C2B8E8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FEC844-3CE3-9E1D-561F-65256E04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4862CB-AE89-F53E-CBE6-C527B6EAF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486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4F8DADB-12FE-172E-9244-A8BB8E9919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AEABBDB-F138-6847-CA5E-7DA0EEDFE6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FE7E1F-CA43-EFBF-947E-7C9267F86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0C432C-E29E-D3B8-AC56-E06F829D8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37A043-6A8F-6554-056F-723521569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17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BDA391-41BC-8784-7F50-698A57A03A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A5739D-C5BA-22E2-8E9D-19F595042A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5F3F2A-9A84-A233-AFFF-DBD8EA2FA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B273A7-8C01-0B32-D927-A54EF5188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9BCC30-51BC-9E5D-64E0-C4186E67D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173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3F1CD6-FEC7-E737-0A7C-5654D4C48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D5CB1A-09A0-9161-A4F9-739111FAE1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679982-F495-7293-9420-80801866D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CDE3FD-03DF-33F6-1DE8-EADC8FA5C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6B58B4-D4A8-D28F-7E00-2CE7DA7DC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567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57BC8D-CC93-E33B-79AE-AE2CAB14D0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0143E3-8DA8-1924-1FB4-70E8139940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CCBCFA5-4794-6D86-5232-F3142F5158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349ED8-6BCD-343D-89CE-6CA4BDD8B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295D9E-3042-EBF9-590C-6D15DB154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1B38AD-51DE-5A12-AB13-DA2E1E5A6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55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2AD5B5-0AA4-B54A-EDA9-C4F15B3F9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A8EF41-E38C-25BA-18EB-2E978FF3E6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557007-AEFF-29F5-5185-6F3687C24B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DF7C524-F2E7-4F44-4D91-41A1D72A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580C3B5-1FC5-8827-E67A-7137A7D5CF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EBC0B17-37D0-6804-2642-F85E21268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86DB4C3-D99D-66C0-9B9B-7EA3BE896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0B1387E-978A-9A80-E28C-E0F9DA3FE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786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D41263-06DA-4F04-E1D6-77EDC9513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D4832DD-62AD-81AE-42D3-F0B25D395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0E13C27-E914-7074-876C-16E94812D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DAA2339-A053-13A5-6AD4-BAABA0070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318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D530694-D296-03C8-F4D5-9DE351A66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C64E79D-6A5C-CA72-C94F-A3E2C1A15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DC5F7FD-D4BD-6C5B-5194-1AC3EB42B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750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7B202E-6E1B-BDF9-F7FF-9AA9328D8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529CAD-7770-44A5-00AB-2C3B356EF0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DD6EE63-BE28-B8D0-57AA-064197EAFF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B4F50D-30FD-EA7E-FAC9-5E56B933B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B0D5C2-601D-5FC0-FD06-9A6D0E8EB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95EBB8-A87D-5FCB-95D4-897BD1E31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787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5901B9-027C-8CF8-B66F-D01D5AE3F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A623BA3-F2C7-E504-C748-B839E2523B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07837E-40DB-31B6-5C90-5B263A64C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B9F8B2-5AB9-899D-82E7-2F246515C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67CE2C-2F2C-11FE-EE36-C155014E7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35A3879-3D86-6ED3-0BAB-F98B80C0F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547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2BFEDC-5E77-D0D7-D3FE-0DA0E0ECB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56CCB6-60C8-67B7-381C-B0006635C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42A2E9-A0C1-0081-604B-10C2D16DA7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C0A2F7-0AAA-B474-9AF4-84E6FCE3F3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183C30-2FBD-BC16-D0CC-FF7480F55E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895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A4D576-03D8-4327-B0C5-C199A83E0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5873" y="134136"/>
            <a:ext cx="11035145" cy="329624"/>
          </a:xfrm>
        </p:spPr>
        <p:txBody>
          <a:bodyPr>
            <a:normAutofit fontScale="90000"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Table. Day of therapy (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) throughout the study period (April 2021 to March 2022) of each category of i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travenous antimicrobial agent in the tertiary care hospital and the community hospital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B60FA08A-51CC-4412-87A2-51C4394704BA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905539" y="632460"/>
          <a:ext cx="10835811" cy="55930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325321">
                  <a:extLst>
                    <a:ext uri="{9D8B030D-6E8A-4147-A177-3AD203B41FA5}">
                      <a16:colId xmlns:a16="http://schemas.microsoft.com/office/drawing/2014/main" val="1515668657"/>
                    </a:ext>
                  </a:extLst>
                </a:gridCol>
                <a:gridCol w="1713823">
                  <a:extLst>
                    <a:ext uri="{9D8B030D-6E8A-4147-A177-3AD203B41FA5}">
                      <a16:colId xmlns:a16="http://schemas.microsoft.com/office/drawing/2014/main" val="1712519199"/>
                    </a:ext>
                  </a:extLst>
                </a:gridCol>
                <a:gridCol w="2073752">
                  <a:extLst>
                    <a:ext uri="{9D8B030D-6E8A-4147-A177-3AD203B41FA5}">
                      <a16:colId xmlns:a16="http://schemas.microsoft.com/office/drawing/2014/main" val="2105135364"/>
                    </a:ext>
                  </a:extLst>
                </a:gridCol>
                <a:gridCol w="1743139">
                  <a:extLst>
                    <a:ext uri="{9D8B030D-6E8A-4147-A177-3AD203B41FA5}">
                      <a16:colId xmlns:a16="http://schemas.microsoft.com/office/drawing/2014/main" val="105477765"/>
                    </a:ext>
                  </a:extLst>
                </a:gridCol>
                <a:gridCol w="1979776">
                  <a:extLst>
                    <a:ext uri="{9D8B030D-6E8A-4147-A177-3AD203B41FA5}">
                      <a16:colId xmlns:a16="http://schemas.microsoft.com/office/drawing/2014/main" val="475524870"/>
                    </a:ext>
                  </a:extLst>
                </a:gridCol>
              </a:tblGrid>
              <a:tr h="240452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y of intravenous antimicrobial agents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T (Day of therapy /100 bed days ) </a:t>
                      </a:r>
                      <a:r>
                        <a:rPr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roughout the study period 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63001003"/>
                  </a:ext>
                </a:extLst>
              </a:tr>
              <a:tr h="39603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tiary care hospit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tiary care hospital, excluding the division of hematolog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munity hospital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munity hospital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cute-phase medical wards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2762099"/>
                  </a:ext>
                </a:extLst>
              </a:tr>
              <a:tr h="39603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oad-spectrum antibiotics predominantly used for hospital-onset infections</a:t>
                      </a:r>
                      <a:r>
                        <a:rPr kumimoji="1" lang="en-US" altLang="ja-JP" sz="11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10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2 (33.6%)</a:t>
                      </a:r>
                      <a:endParaRPr lang="en-US" altLang="ja-JP" sz="11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4 (30.0%)</a:t>
                      </a:r>
                      <a:endParaRPr lang="en-US" altLang="ja-JP" sz="11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8 (19.8%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9 (18.6%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6203131"/>
                  </a:ext>
                </a:extLst>
              </a:tr>
              <a:tr h="39603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iotics predominantly used for community acquired infections</a:t>
                      </a:r>
                      <a:r>
                        <a:rPr lang="en-US" altLang="ja-JP" sz="11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10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2 (15.9 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9 (19.4 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5 (32.8%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0 (31.6%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5585249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iotics used for resistant gram-positive infections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0 (7.8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8 (7.1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 (2.0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 (1.7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23057521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fungal agents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8 (5.9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 (1.8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 (0.9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 (1.0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86753280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rst- and second-generation </a:t>
                      </a:r>
                      <a:r>
                        <a:rPr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phalosporins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9 (27.3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24 (33.2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3 (21.1%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9 (21.3%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67827545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nicillin G, ampicillin, piperacillin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 (1.3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 (1.6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4 (8.6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3 (15.0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96680533"/>
                  </a:ext>
                </a:extLst>
              </a:tr>
              <a:tr h="396038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iotics predominantly used for extensively antibiotic resistant bacteria</a:t>
                      </a:r>
                      <a:r>
                        <a:rPr lang="en-US" altLang="ja-JP" sz="11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§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(0.1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(0.1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72900563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</a:t>
                      </a:r>
                      <a:r>
                        <a:rPr kumimoji="1" lang="el-GR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ams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(0.1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(0.1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(1.2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 (1.2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13035223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damycin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 (2.7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 (3.3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 (1.0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 (0.9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11141114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ronidazol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 (0.8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 (1.0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(0.4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 (0.4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77158916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ocyclin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 (0.3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 (0.4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(0.1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04696500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inoglycoside except for arbekacin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 (0.4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(0.3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 (0.6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 (0.38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64573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sfomycin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(0.1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(0.1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(0.1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(0.2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05362610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avenous sulfamethoxazole trimethoprim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 (0.9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 (0.4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20616753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SARS CoV-2 (</a:t>
                      </a:r>
                      <a:r>
                        <a:rPr kumimoji="1" lang="en-US" altLang="ja-JP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desivir)</a:t>
                      </a:r>
                      <a:endParaRPr kumimoji="1" lang="en-US" altLang="ja-JP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(0.1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(0.2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 (10.9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1 (12.5%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42868944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</a:t>
                      </a: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viral agents 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 (2.6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 (1.2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 (0.6%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 (0.6%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1810835"/>
                  </a:ext>
                </a:extLst>
              </a:tr>
              <a:tr h="24045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18 (100.0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83 (100.0%)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u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08 (100%)</a:t>
                      </a:r>
                      <a:endParaRPr kumimoji="1" lang="en-US" altLang="ja-JP" sz="1100" b="0" u="non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u="non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9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69489262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F8AD9E7-9DA4-4F18-8EF1-1DD7682A0B43}"/>
              </a:ext>
            </a:extLst>
          </p:cNvPr>
          <p:cNvSpPr txBox="1"/>
          <p:nvPr/>
        </p:nvSpPr>
        <p:spPr>
          <a:xfrm>
            <a:off x="671120" y="6225540"/>
            <a:ext cx="11520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rbapenems,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peracillin/tazobactam, fourth-generation cephalosporines/ceftazidime/aztreonam, and fluoroquinolone; 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ftriaxone/ cefotaxime, ampicillin/sulbactam, and macrolides; 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§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istin, tigecycline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ftolozan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tazobactam, imipenem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lastati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ebacta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069759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30</TotalTime>
  <Words>465</Words>
  <Application>Microsoft Office PowerPoint</Application>
  <PresentationFormat>ワイド画面</PresentationFormat>
  <Paragraphs>9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S3 Table. Day of therapy (DOT) throughout the study period (April 2021 to March 2022) of each category of intravenous antimicrobial agent in the tertiary care hospital and the community hospital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E_Mente</dc:creator>
  <cp:lastModifiedBy>植田貴史</cp:lastModifiedBy>
  <cp:revision>312</cp:revision>
  <cp:lastPrinted>2023-04-12T10:42:11Z</cp:lastPrinted>
  <dcterms:created xsi:type="dcterms:W3CDTF">2022-09-14T02:01:21Z</dcterms:created>
  <dcterms:modified xsi:type="dcterms:W3CDTF">2023-04-12T10:44:24Z</dcterms:modified>
</cp:coreProperties>
</file>